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60" d="100"/>
          <a:sy n="60" d="100"/>
        </p:scale>
        <p:origin x="840" y="4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930811AA-340D-4F57-D6E3-C83EE8D4501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>
            <a:extLst>
              <a:ext uri="{FF2B5EF4-FFF2-40B4-BE49-F238E27FC236}">
                <a16:creationId xmlns:a16="http://schemas.microsoft.com/office/drawing/2014/main" id="{8FC6B80E-BE12-8B3D-950C-3CDA7CEECD2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子標題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68DD3D13-2FF4-5E4D-FD38-BF06297918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3851BB-3BE0-43B2-874C-7D0F1A6B3ED8}" type="datetimeFigureOut">
              <a:rPr lang="zh-TW" altLang="en-US" smtClean="0"/>
              <a:t>2023/9/12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BBC3B161-53D9-FA47-FEF7-334A3F852C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B792C5F5-A773-9511-36FD-98077C61AB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570F6-ECD1-4E25-A2B6-2E706297C1C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5232290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04E52FE1-64E1-55EA-0E20-151AE8EABE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F39C9E94-2D9E-61BE-B325-408EBF9D487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EFF1E257-0107-2242-EB63-9092041AEC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3851BB-3BE0-43B2-874C-7D0F1A6B3ED8}" type="datetimeFigureOut">
              <a:rPr lang="zh-TW" altLang="en-US" smtClean="0"/>
              <a:t>2023/9/12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8E71F135-8F00-7185-60BF-8DAFCB3B10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97C2B5A7-6DD9-FAAE-30F6-6D4726A651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570F6-ECD1-4E25-A2B6-2E706297C1C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824435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>
            <a:extLst>
              <a:ext uri="{FF2B5EF4-FFF2-40B4-BE49-F238E27FC236}">
                <a16:creationId xmlns:a16="http://schemas.microsoft.com/office/drawing/2014/main" id="{FAB35B8F-3B56-7EA4-ADA5-618772B37F8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6E2F0003-F086-DD91-51E6-61FC4043E87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06617085-5183-6334-382A-C408040045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3851BB-3BE0-43B2-874C-7D0F1A6B3ED8}" type="datetimeFigureOut">
              <a:rPr lang="zh-TW" altLang="en-US" smtClean="0"/>
              <a:t>2023/9/12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5BA3B1A1-9DD4-1447-DAAB-BC1162DCD3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A99D3F61-E837-DA82-FBEB-84C1962AE1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570F6-ECD1-4E25-A2B6-2E706297C1C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65587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E02302C8-83E6-7FD4-EA05-FF1355915D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CC066E6B-4FF8-B1B5-9DC1-D9CD11DDEAA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63CEC3DB-4D99-DFD0-CE38-B05A20CA19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3851BB-3BE0-43B2-874C-7D0F1A6B3ED8}" type="datetimeFigureOut">
              <a:rPr lang="zh-TW" altLang="en-US" smtClean="0"/>
              <a:t>2023/9/12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FD3C38FF-3537-383A-AEA6-FD9B5904F5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64377497-4AA3-66D9-100A-1CA174B5D0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570F6-ECD1-4E25-A2B6-2E706297C1C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8617730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26F6E29E-9E20-3E1A-3A1C-BAA574E011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E8735E6D-948A-BDA4-DC73-8E756EC9E1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127F832A-9B20-EEAD-423C-2D6961B17B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3851BB-3BE0-43B2-874C-7D0F1A6B3ED8}" type="datetimeFigureOut">
              <a:rPr lang="zh-TW" altLang="en-US" smtClean="0"/>
              <a:t>2023/9/12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747D17CE-74F5-ADBC-6E24-3CF3A2A8B4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104886CE-DF10-7CA6-874B-A9E2B6C335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570F6-ECD1-4E25-A2B6-2E706297C1C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520157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6CFEF51B-4B13-B031-856D-B309464412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D10C6CEC-B837-A387-8966-1E4B0D9F02E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60CEBDF4-E15D-6244-7D0F-881903A24AB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B4DD8198-774D-67E0-235C-7FAAE5E8FD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3851BB-3BE0-43B2-874C-7D0F1A6B3ED8}" type="datetimeFigureOut">
              <a:rPr lang="zh-TW" altLang="en-US" smtClean="0"/>
              <a:t>2023/9/12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70FB30E6-FADF-C8C1-A89F-B90818ECF5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0C40D3F8-3954-8F67-C5A4-65014216B7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570F6-ECD1-4E25-A2B6-2E706297C1C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0021084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8FCB921C-76FB-5CF3-0034-0D04FF2315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1728E288-3216-98ED-5837-34AF87EEF0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31E41F5D-F3E8-EBB9-1E4B-FEE632B547D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>
            <a:extLst>
              <a:ext uri="{FF2B5EF4-FFF2-40B4-BE49-F238E27FC236}">
                <a16:creationId xmlns:a16="http://schemas.microsoft.com/office/drawing/2014/main" id="{FD245979-CC25-6954-4A61-24AED55250C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內容版面配置區 5">
            <a:extLst>
              <a:ext uri="{FF2B5EF4-FFF2-40B4-BE49-F238E27FC236}">
                <a16:creationId xmlns:a16="http://schemas.microsoft.com/office/drawing/2014/main" id="{909EB5A7-B503-9E03-4C8C-FAD6E93544C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>
            <a:extLst>
              <a:ext uri="{FF2B5EF4-FFF2-40B4-BE49-F238E27FC236}">
                <a16:creationId xmlns:a16="http://schemas.microsoft.com/office/drawing/2014/main" id="{22DEE84D-3BDC-B7C6-D9C7-3F1F7F42DF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3851BB-3BE0-43B2-874C-7D0F1A6B3ED8}" type="datetimeFigureOut">
              <a:rPr lang="zh-TW" altLang="en-US" smtClean="0"/>
              <a:t>2023/9/12</a:t>
            </a:fld>
            <a:endParaRPr lang="zh-TW" altLang="en-US"/>
          </a:p>
        </p:txBody>
      </p:sp>
      <p:sp>
        <p:nvSpPr>
          <p:cNvPr id="8" name="頁尾版面配置區 7">
            <a:extLst>
              <a:ext uri="{FF2B5EF4-FFF2-40B4-BE49-F238E27FC236}">
                <a16:creationId xmlns:a16="http://schemas.microsoft.com/office/drawing/2014/main" id="{2B948B90-E690-435E-404B-0476D35D44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>
            <a:extLst>
              <a:ext uri="{FF2B5EF4-FFF2-40B4-BE49-F238E27FC236}">
                <a16:creationId xmlns:a16="http://schemas.microsoft.com/office/drawing/2014/main" id="{01EACE67-9D5B-C4AB-7C52-B0EF0ABD71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570F6-ECD1-4E25-A2B6-2E706297C1C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989114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704F804A-E761-04DA-B5AE-83080BFC09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>
            <a:extLst>
              <a:ext uri="{FF2B5EF4-FFF2-40B4-BE49-F238E27FC236}">
                <a16:creationId xmlns:a16="http://schemas.microsoft.com/office/drawing/2014/main" id="{DB614F98-D978-2D1E-52EE-67F27343F7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3851BB-3BE0-43B2-874C-7D0F1A6B3ED8}" type="datetimeFigureOut">
              <a:rPr lang="zh-TW" altLang="en-US" smtClean="0"/>
              <a:t>2023/9/12</a:t>
            </a:fld>
            <a:endParaRPr lang="zh-TW" altLang="en-US"/>
          </a:p>
        </p:txBody>
      </p:sp>
      <p:sp>
        <p:nvSpPr>
          <p:cNvPr id="4" name="頁尾版面配置區 3">
            <a:extLst>
              <a:ext uri="{FF2B5EF4-FFF2-40B4-BE49-F238E27FC236}">
                <a16:creationId xmlns:a16="http://schemas.microsoft.com/office/drawing/2014/main" id="{342A79E3-3B54-AB15-EB39-78E94C3EDC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>
            <a:extLst>
              <a:ext uri="{FF2B5EF4-FFF2-40B4-BE49-F238E27FC236}">
                <a16:creationId xmlns:a16="http://schemas.microsoft.com/office/drawing/2014/main" id="{129238E8-7718-006C-7EBD-0E8BCE3237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570F6-ECD1-4E25-A2B6-2E706297C1C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4980562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>
            <a:extLst>
              <a:ext uri="{FF2B5EF4-FFF2-40B4-BE49-F238E27FC236}">
                <a16:creationId xmlns:a16="http://schemas.microsoft.com/office/drawing/2014/main" id="{1EB0E562-CE03-F5F8-237C-5888BCE894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3851BB-3BE0-43B2-874C-7D0F1A6B3ED8}" type="datetimeFigureOut">
              <a:rPr lang="zh-TW" altLang="en-US" smtClean="0"/>
              <a:t>2023/9/12</a:t>
            </a:fld>
            <a:endParaRPr lang="zh-TW" altLang="en-US"/>
          </a:p>
        </p:txBody>
      </p:sp>
      <p:sp>
        <p:nvSpPr>
          <p:cNvPr id="3" name="頁尾版面配置區 2">
            <a:extLst>
              <a:ext uri="{FF2B5EF4-FFF2-40B4-BE49-F238E27FC236}">
                <a16:creationId xmlns:a16="http://schemas.microsoft.com/office/drawing/2014/main" id="{8A13BA4E-A772-E7E7-29CA-80C35DCCFE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>
            <a:extLst>
              <a:ext uri="{FF2B5EF4-FFF2-40B4-BE49-F238E27FC236}">
                <a16:creationId xmlns:a16="http://schemas.microsoft.com/office/drawing/2014/main" id="{1C1AF436-7659-46FF-F26A-8E8F22712B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570F6-ECD1-4E25-A2B6-2E706297C1C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1295738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輔助字幕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1AA9E81F-2960-E3D8-FF85-91C8B84FFD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7DB79D5A-43F2-5E09-B86F-C66C172FD30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624CB73D-DD9E-BA17-B725-A8676953CC8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B2335462-148A-021D-A5A6-07045E9CA4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3851BB-3BE0-43B2-874C-7D0F1A6B3ED8}" type="datetimeFigureOut">
              <a:rPr lang="zh-TW" altLang="en-US" smtClean="0"/>
              <a:t>2023/9/12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6CF1F27A-FE89-0796-4338-FD47478C65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8EB5853B-AEF7-A430-42D8-1D234AD12A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570F6-ECD1-4E25-A2B6-2E706297C1C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61272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輔助字幕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56233962-6038-2CB7-FF2C-1C8227F94D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>
            <a:extLst>
              <a:ext uri="{FF2B5EF4-FFF2-40B4-BE49-F238E27FC236}">
                <a16:creationId xmlns:a16="http://schemas.microsoft.com/office/drawing/2014/main" id="{2BEB9605-6A90-5602-58F6-CE23633D448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4F9AB7AF-2A61-E163-4304-2DBF6E57C1D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97778DB7-9C1A-54EE-1F86-F28BD697B2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3851BB-3BE0-43B2-874C-7D0F1A6B3ED8}" type="datetimeFigureOut">
              <a:rPr lang="zh-TW" altLang="en-US" smtClean="0"/>
              <a:t>2023/9/12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C8F6914C-8920-296B-3C60-0F2797214F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F1F96B3E-97FB-6BC1-1F3E-665AA14323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570F6-ECD1-4E25-A2B6-2E706297C1C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141389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>
            <a:extLst>
              <a:ext uri="{FF2B5EF4-FFF2-40B4-BE49-F238E27FC236}">
                <a16:creationId xmlns:a16="http://schemas.microsoft.com/office/drawing/2014/main" id="{411E0C6D-E39E-2B37-5BDC-0FBA4015BF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0FB17E46-2C1E-6539-3930-2BABBFAA9C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CA248075-B597-FDDD-B3B4-C13712B5487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3851BB-3BE0-43B2-874C-7D0F1A6B3ED8}" type="datetimeFigureOut">
              <a:rPr lang="zh-TW" altLang="en-US" smtClean="0"/>
              <a:t>2023/9/12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D7D250F1-FB03-821F-B7A3-B60003B0B99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60EFED43-3240-F200-A5A1-BCB2B3C42FD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7570F6-ECD1-4E25-A2B6-2E706297C1C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7072636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標題 1">
            <a:extLst>
              <a:ext uri="{FF2B5EF4-FFF2-40B4-BE49-F238E27FC236}">
                <a16:creationId xmlns:a16="http://schemas.microsoft.com/office/drawing/2014/main" id="{4C83507F-3F30-6D1A-0976-8C50A96431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</p:spPr>
        <p:txBody>
          <a:bodyPr/>
          <a:lstStyle/>
          <a:p>
            <a:r>
              <a:rPr lang="en-US" altLang="zh-TW" dirty="0"/>
              <a:t>Supplement Table 3. Inference result of model trained in separated classes dataset.</a:t>
            </a:r>
            <a:endParaRPr lang="zh-TW" altLang="en-US" dirty="0"/>
          </a:p>
        </p:txBody>
      </p:sp>
      <p:graphicFrame>
        <p:nvGraphicFramePr>
          <p:cNvPr id="6" name="表格 5">
            <a:extLst>
              <a:ext uri="{FF2B5EF4-FFF2-40B4-BE49-F238E27FC236}">
                <a16:creationId xmlns:a16="http://schemas.microsoft.com/office/drawing/2014/main" id="{14D8E849-0B01-BA58-134E-6B5AC901D36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93048348"/>
              </p:ext>
            </p:extLst>
          </p:nvPr>
        </p:nvGraphicFramePr>
        <p:xfrm>
          <a:off x="958585" y="2016055"/>
          <a:ext cx="8124094" cy="1755693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1887415">
                  <a:extLst>
                    <a:ext uri="{9D8B030D-6E8A-4147-A177-3AD203B41FA5}">
                      <a16:colId xmlns:a16="http://schemas.microsoft.com/office/drawing/2014/main" val="2805986545"/>
                    </a:ext>
                  </a:extLst>
                </a:gridCol>
                <a:gridCol w="1887415">
                  <a:extLst>
                    <a:ext uri="{9D8B030D-6E8A-4147-A177-3AD203B41FA5}">
                      <a16:colId xmlns:a16="http://schemas.microsoft.com/office/drawing/2014/main" val="2464116475"/>
                    </a:ext>
                  </a:extLst>
                </a:gridCol>
                <a:gridCol w="1087316">
                  <a:extLst>
                    <a:ext uri="{9D8B030D-6E8A-4147-A177-3AD203B41FA5}">
                      <a16:colId xmlns:a16="http://schemas.microsoft.com/office/drawing/2014/main" val="3639535370"/>
                    </a:ext>
                  </a:extLst>
                </a:gridCol>
                <a:gridCol w="1087316">
                  <a:extLst>
                    <a:ext uri="{9D8B030D-6E8A-4147-A177-3AD203B41FA5}">
                      <a16:colId xmlns:a16="http://schemas.microsoft.com/office/drawing/2014/main" val="736726097"/>
                    </a:ext>
                  </a:extLst>
                </a:gridCol>
                <a:gridCol w="1087316">
                  <a:extLst>
                    <a:ext uri="{9D8B030D-6E8A-4147-A177-3AD203B41FA5}">
                      <a16:colId xmlns:a16="http://schemas.microsoft.com/office/drawing/2014/main" val="215707002"/>
                    </a:ext>
                  </a:extLst>
                </a:gridCol>
                <a:gridCol w="1087316">
                  <a:extLst>
                    <a:ext uri="{9D8B030D-6E8A-4147-A177-3AD203B41FA5}">
                      <a16:colId xmlns:a16="http://schemas.microsoft.com/office/drawing/2014/main" val="3509853126"/>
                    </a:ext>
                  </a:extLst>
                </a:gridCol>
              </a:tblGrid>
              <a:tr h="314504">
                <a:tc>
                  <a:txBody>
                    <a:bodyPr/>
                    <a:lstStyle/>
                    <a:p>
                      <a:r>
                        <a:rPr lang="en-US" sz="1400" u="none" kern="10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zh-TW" sz="1400" u="none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400" u="none" kern="100" dirty="0">
                          <a:solidFill>
                            <a:schemeClr val="tx1"/>
                          </a:solidFill>
                          <a:effectLst/>
                        </a:rPr>
                        <a:t>3D metric</a:t>
                      </a:r>
                      <a:endParaRPr lang="zh-TW" sz="1400" u="none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400" u="none" kern="100">
                          <a:solidFill>
                            <a:schemeClr val="tx1"/>
                          </a:solidFill>
                          <a:effectLst/>
                        </a:rPr>
                        <a:t>ENE</a:t>
                      </a:r>
                      <a:endParaRPr lang="zh-TW" sz="1400" u="none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400" u="none" kern="100">
                          <a:solidFill>
                            <a:schemeClr val="tx1"/>
                          </a:solidFill>
                          <a:effectLst/>
                        </a:rPr>
                        <a:t>P</a:t>
                      </a:r>
                      <a:endParaRPr lang="zh-TW" sz="1400" u="none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400" u="none" kern="100">
                          <a:solidFill>
                            <a:schemeClr val="tx1"/>
                          </a:solidFill>
                          <a:effectLst/>
                        </a:rPr>
                        <a:t>N</a:t>
                      </a:r>
                      <a:endParaRPr lang="zh-TW" sz="1400" u="none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400" u="none" kern="100" dirty="0">
                          <a:solidFill>
                            <a:schemeClr val="tx1"/>
                          </a:solidFill>
                          <a:effectLst/>
                        </a:rPr>
                        <a:t>Total </a:t>
                      </a:r>
                      <a:endParaRPr lang="zh-TW" sz="1400" u="none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 anchor="ctr"/>
                </a:tc>
                <a:extLst>
                  <a:ext uri="{0D108BD9-81ED-4DB2-BD59-A6C34878D82A}">
                    <a16:rowId xmlns:a16="http://schemas.microsoft.com/office/drawing/2014/main" val="2538894963"/>
                  </a:ext>
                </a:extLst>
              </a:tr>
              <a:tr h="314504">
                <a:tc rowSpan="4">
                  <a:txBody>
                    <a:bodyPr/>
                    <a:lstStyle/>
                    <a:p>
                      <a:r>
                        <a:rPr lang="en-US" sz="1400" u="none" kern="100" dirty="0">
                          <a:solidFill>
                            <a:schemeClr val="tx1"/>
                          </a:solidFill>
                          <a:effectLst/>
                        </a:rPr>
                        <a:t>Without </a:t>
                      </a:r>
                      <a:endParaRPr lang="zh-TW" sz="1400" u="none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400" u="none" kern="100" dirty="0">
                          <a:solidFill>
                            <a:schemeClr val="tx1"/>
                          </a:solidFill>
                          <a:effectLst/>
                        </a:rPr>
                        <a:t>Dice </a:t>
                      </a:r>
                      <a:endParaRPr lang="zh-TW" sz="1400" u="none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400" u="none" kern="100" dirty="0">
                          <a:solidFill>
                            <a:schemeClr val="tx1"/>
                          </a:solidFill>
                          <a:effectLst/>
                        </a:rPr>
                        <a:t>63.01</a:t>
                      </a:r>
                      <a:endParaRPr lang="zh-TW" sz="1400" u="none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400" u="none" kern="100" dirty="0">
                          <a:solidFill>
                            <a:schemeClr val="tx1"/>
                          </a:solidFill>
                          <a:effectLst/>
                        </a:rPr>
                        <a:t>56.06</a:t>
                      </a:r>
                      <a:endParaRPr lang="zh-TW" sz="1400" u="none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400" u="none" kern="100" dirty="0">
                          <a:solidFill>
                            <a:schemeClr val="tx1"/>
                          </a:solidFill>
                          <a:effectLst/>
                        </a:rPr>
                        <a:t>59.35</a:t>
                      </a:r>
                      <a:endParaRPr lang="zh-TW" sz="1400" u="none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400" u="none" kern="100" dirty="0">
                          <a:solidFill>
                            <a:schemeClr val="tx1"/>
                          </a:solidFill>
                          <a:effectLst/>
                        </a:rPr>
                        <a:t>71.00</a:t>
                      </a:r>
                      <a:endParaRPr lang="zh-TW" sz="1400" u="none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52488113"/>
                  </a:ext>
                </a:extLst>
              </a:tr>
              <a:tr h="314504"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u="none" kern="100">
                          <a:solidFill>
                            <a:schemeClr val="tx1"/>
                          </a:solidFill>
                          <a:effectLst/>
                        </a:rPr>
                        <a:t>Detection rate (&gt;0)</a:t>
                      </a:r>
                      <a:endParaRPr lang="zh-TW" sz="1400" u="none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400" u="none" kern="100">
                          <a:solidFill>
                            <a:schemeClr val="tx1"/>
                          </a:solidFill>
                          <a:effectLst/>
                        </a:rPr>
                        <a:t>90.00</a:t>
                      </a:r>
                      <a:endParaRPr lang="zh-TW" sz="1400" u="none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400" u="none" kern="100" dirty="0">
                          <a:solidFill>
                            <a:schemeClr val="tx1"/>
                          </a:solidFill>
                          <a:effectLst/>
                        </a:rPr>
                        <a:t>73.33</a:t>
                      </a:r>
                      <a:endParaRPr lang="zh-TW" sz="1400" u="none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400" u="none" kern="100">
                          <a:solidFill>
                            <a:schemeClr val="tx1"/>
                          </a:solidFill>
                          <a:effectLst/>
                        </a:rPr>
                        <a:t>76.58</a:t>
                      </a:r>
                      <a:endParaRPr lang="zh-TW" sz="1400" u="none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400" u="none" kern="100" dirty="0">
                          <a:solidFill>
                            <a:schemeClr val="tx1"/>
                          </a:solidFill>
                          <a:effectLst/>
                        </a:rPr>
                        <a:t>79.97</a:t>
                      </a:r>
                      <a:endParaRPr lang="zh-TW" sz="1400" u="none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 anchor="ctr"/>
                </a:tc>
                <a:extLst>
                  <a:ext uri="{0D108BD9-81ED-4DB2-BD59-A6C34878D82A}">
                    <a16:rowId xmlns:a16="http://schemas.microsoft.com/office/drawing/2014/main" val="2190248870"/>
                  </a:ext>
                </a:extLst>
              </a:tr>
              <a:tr h="497677"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u="none" kern="100" dirty="0">
                          <a:solidFill>
                            <a:schemeClr val="tx1"/>
                          </a:solidFill>
                          <a:effectLst/>
                        </a:rPr>
                        <a:t>Detection rate (&gt;50)</a:t>
                      </a:r>
                      <a:endParaRPr lang="zh-TW" sz="1400" u="none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400" u="none" kern="100" dirty="0">
                          <a:solidFill>
                            <a:schemeClr val="tx1"/>
                          </a:solidFill>
                          <a:effectLst/>
                        </a:rPr>
                        <a:t>60.00</a:t>
                      </a:r>
                      <a:endParaRPr lang="zh-TW" sz="1400" u="none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400" u="none" kern="100">
                          <a:solidFill>
                            <a:schemeClr val="tx1"/>
                          </a:solidFill>
                          <a:effectLst/>
                        </a:rPr>
                        <a:t>66.67</a:t>
                      </a:r>
                      <a:endParaRPr lang="zh-TW" sz="1400" u="none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400" u="none" kern="100">
                          <a:solidFill>
                            <a:schemeClr val="tx1"/>
                          </a:solidFill>
                          <a:effectLst/>
                        </a:rPr>
                        <a:t>59.46</a:t>
                      </a:r>
                      <a:endParaRPr lang="zh-TW" sz="1400" u="none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400" u="none" kern="100" dirty="0">
                          <a:solidFill>
                            <a:schemeClr val="tx1"/>
                          </a:solidFill>
                          <a:effectLst/>
                        </a:rPr>
                        <a:t>62.04</a:t>
                      </a:r>
                      <a:endParaRPr lang="zh-TW" sz="1400" u="none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 anchor="ctr"/>
                </a:tc>
                <a:extLst>
                  <a:ext uri="{0D108BD9-81ED-4DB2-BD59-A6C34878D82A}">
                    <a16:rowId xmlns:a16="http://schemas.microsoft.com/office/drawing/2014/main" val="286106890"/>
                  </a:ext>
                </a:extLst>
              </a:tr>
              <a:tr h="314504"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u="none" kern="100">
                          <a:solidFill>
                            <a:schemeClr val="tx1"/>
                          </a:solidFill>
                          <a:effectLst/>
                        </a:rPr>
                        <a:t>FP/image</a:t>
                      </a:r>
                      <a:endParaRPr lang="zh-TW" sz="1400" u="none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400" u="none" kern="100">
                          <a:solidFill>
                            <a:schemeClr val="tx1"/>
                          </a:solidFill>
                          <a:effectLst/>
                        </a:rPr>
                        <a:t>1.43</a:t>
                      </a:r>
                      <a:endParaRPr lang="zh-TW" sz="1400" u="none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400" u="none" kern="100">
                          <a:solidFill>
                            <a:schemeClr val="tx1"/>
                          </a:solidFill>
                          <a:effectLst/>
                        </a:rPr>
                        <a:t>1.00</a:t>
                      </a:r>
                      <a:endParaRPr lang="zh-TW" sz="1400" u="none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400" u="none" kern="100">
                          <a:solidFill>
                            <a:schemeClr val="tx1"/>
                          </a:solidFill>
                          <a:effectLst/>
                        </a:rPr>
                        <a:t>4.64</a:t>
                      </a:r>
                      <a:endParaRPr lang="zh-TW" sz="1400" u="none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 anchor="ctr"/>
                </a:tc>
                <a:tc>
                  <a:txBody>
                    <a:bodyPr/>
                    <a:lstStyle/>
                    <a:p>
                      <a:r>
                        <a:rPr lang="en-US" sz="1400" u="none" kern="100" dirty="0">
                          <a:solidFill>
                            <a:schemeClr val="tx1"/>
                          </a:solidFill>
                          <a:effectLst/>
                        </a:rPr>
                        <a:t>2.36</a:t>
                      </a:r>
                      <a:endParaRPr lang="zh-TW" sz="1400" u="none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 anchor="ctr"/>
                </a:tc>
                <a:extLst>
                  <a:ext uri="{0D108BD9-81ED-4DB2-BD59-A6C34878D82A}">
                    <a16:rowId xmlns:a16="http://schemas.microsoft.com/office/drawing/2014/main" val="52094672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97723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2</Words>
  <Application>Microsoft Office PowerPoint</Application>
  <PresentationFormat>寬螢幕</PresentationFormat>
  <Paragraphs>28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3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佈景主題</vt:lpstr>
      <vt:lpstr>Supplement Table 3. Inference result of model trained in separated classes dataset.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 Table 3. Inference result of model trained in separated classes dataset.</dc:title>
  <dc:creator>聖耀 黃</dc:creator>
  <cp:lastModifiedBy>聖耀 黃</cp:lastModifiedBy>
  <cp:revision>1</cp:revision>
  <dcterms:created xsi:type="dcterms:W3CDTF">2023-09-12T09:05:09Z</dcterms:created>
  <dcterms:modified xsi:type="dcterms:W3CDTF">2023-09-12T09:05:36Z</dcterms:modified>
</cp:coreProperties>
</file>